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57" r:id="rId3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3846BF-2323-47C4-B319-79A6E50CF08E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7479CD-8035-43A9-85C5-3147A2DB92D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68588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MX" dirty="0" err="1" smtClean="0"/>
              <a:t>Cibarium</a:t>
            </a:r>
            <a:r>
              <a:rPr lang="es-MX" baseline="0" dirty="0" smtClean="0"/>
              <a:t> con aproximadamente 14 dientes horizontales en una fila en forma de peine;  </a:t>
            </a:r>
            <a:r>
              <a:rPr lang="es-MX" dirty="0" smtClean="0"/>
              <a:t>Vena R1</a:t>
            </a:r>
            <a:r>
              <a:rPr lang="es-MX" baseline="0" dirty="0" smtClean="0"/>
              <a:t> con terminación de más o menos a la mitad de la vena R2 del ala; </a:t>
            </a:r>
            <a:r>
              <a:rPr lang="es-MX" baseline="0" dirty="0" err="1" smtClean="0"/>
              <a:t>espermateca</a:t>
            </a:r>
            <a:r>
              <a:rPr lang="es-MX" baseline="0" dirty="0" smtClean="0"/>
              <a:t> periforme con estrías y anillos en su unión con el conducto </a:t>
            </a:r>
            <a:r>
              <a:rPr lang="es-MX" baseline="0" dirty="0" err="1" smtClean="0"/>
              <a:t>espermatecal</a:t>
            </a:r>
            <a:r>
              <a:rPr lang="es-MX" baseline="0" dirty="0" smtClean="0"/>
              <a:t> (individual). (</a:t>
            </a:r>
            <a:r>
              <a:rPr lang="es-MX" baseline="0" dirty="0" err="1" smtClean="0"/>
              <a:t>Ibañez</a:t>
            </a:r>
            <a:r>
              <a:rPr lang="es-MX" baseline="0" dirty="0" smtClean="0"/>
              <a:t>-Bernal, 2009).</a:t>
            </a: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5A858A-464D-4385-82EC-A2D835818226}" type="slidenum">
              <a:rPr lang="es-MX" smtClean="0"/>
              <a:t>1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947297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6E13-1C93-468F-943A-D04C2B380AB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97F1F-CED7-4A40-A8ED-B9CF7009C38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45251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6E13-1C93-468F-943A-D04C2B380AB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97F1F-CED7-4A40-A8ED-B9CF7009C38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177600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6E13-1C93-468F-943A-D04C2B380AB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97F1F-CED7-4A40-A8ED-B9CF7009C38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79008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6E13-1C93-468F-943A-D04C2B380AB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97F1F-CED7-4A40-A8ED-B9CF7009C38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45572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6E13-1C93-468F-943A-D04C2B380AB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97F1F-CED7-4A40-A8ED-B9CF7009C38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229542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6E13-1C93-468F-943A-D04C2B380AB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97F1F-CED7-4A40-A8ED-B9CF7009C38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484592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6E13-1C93-468F-943A-D04C2B380AB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97F1F-CED7-4A40-A8ED-B9CF7009C38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58006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6E13-1C93-468F-943A-D04C2B380AB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97F1F-CED7-4A40-A8ED-B9CF7009C38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51205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6E13-1C93-468F-943A-D04C2B380AB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97F1F-CED7-4A40-A8ED-B9CF7009C38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951116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6E13-1C93-468F-943A-D04C2B380AB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97F1F-CED7-4A40-A8ED-B9CF7009C38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791654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6E13-1C93-468F-943A-D04C2B380AB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97F1F-CED7-4A40-A8ED-B9CF7009C38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8985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4E6E13-1C93-468F-943A-D04C2B380AB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D97F1F-CED7-4A40-A8ED-B9CF7009C38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3750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908" y="463639"/>
            <a:ext cx="3382246" cy="5665340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3547" y="463639"/>
            <a:ext cx="6177566" cy="2403474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9412469" y="897366"/>
            <a:ext cx="953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 smtClean="0"/>
              <a:t>R3</a:t>
            </a:r>
            <a:endParaRPr lang="es-MX" dirty="0"/>
          </a:p>
        </p:txBody>
      </p:sp>
      <p:sp>
        <p:nvSpPr>
          <p:cNvPr id="8" name="CuadroTexto 7"/>
          <p:cNvSpPr txBox="1"/>
          <p:nvPr/>
        </p:nvSpPr>
        <p:spPr>
          <a:xfrm>
            <a:off x="8152488" y="463639"/>
            <a:ext cx="953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 smtClean="0"/>
              <a:t>R1</a:t>
            </a:r>
            <a:endParaRPr lang="es-MX" dirty="0"/>
          </a:p>
        </p:txBody>
      </p:sp>
      <p:sp>
        <p:nvSpPr>
          <p:cNvPr id="9" name="CuadroTexto 8"/>
          <p:cNvSpPr txBox="1"/>
          <p:nvPr/>
        </p:nvSpPr>
        <p:spPr>
          <a:xfrm>
            <a:off x="8776039" y="622547"/>
            <a:ext cx="953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 smtClean="0"/>
              <a:t>R2</a:t>
            </a:r>
            <a:endParaRPr lang="es-MX" dirty="0"/>
          </a:p>
        </p:txBody>
      </p:sp>
      <p:sp>
        <p:nvSpPr>
          <p:cNvPr id="11" name="CuadroTexto 10"/>
          <p:cNvSpPr txBox="1"/>
          <p:nvPr/>
        </p:nvSpPr>
        <p:spPr>
          <a:xfrm>
            <a:off x="9814936" y="1236218"/>
            <a:ext cx="953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 smtClean="0"/>
              <a:t>R4</a:t>
            </a:r>
            <a:endParaRPr lang="es-MX" dirty="0"/>
          </a:p>
        </p:txBody>
      </p:sp>
      <p:sp>
        <p:nvSpPr>
          <p:cNvPr id="12" name="CuadroTexto 11"/>
          <p:cNvSpPr txBox="1"/>
          <p:nvPr/>
        </p:nvSpPr>
        <p:spPr>
          <a:xfrm>
            <a:off x="9953382" y="1670871"/>
            <a:ext cx="953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 smtClean="0"/>
              <a:t>R5</a:t>
            </a:r>
            <a:endParaRPr lang="es-MX" dirty="0"/>
          </a:p>
        </p:txBody>
      </p:sp>
      <p:sp>
        <p:nvSpPr>
          <p:cNvPr id="13" name="CuadroTexto 12"/>
          <p:cNvSpPr txBox="1"/>
          <p:nvPr/>
        </p:nvSpPr>
        <p:spPr>
          <a:xfrm>
            <a:off x="9715124" y="1962820"/>
            <a:ext cx="953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 smtClean="0"/>
              <a:t>M1</a:t>
            </a:r>
            <a:endParaRPr lang="es-MX" dirty="0"/>
          </a:p>
        </p:txBody>
      </p:sp>
      <p:sp>
        <p:nvSpPr>
          <p:cNvPr id="14" name="CuadroTexto 13"/>
          <p:cNvSpPr txBox="1"/>
          <p:nvPr/>
        </p:nvSpPr>
        <p:spPr>
          <a:xfrm>
            <a:off x="9134502" y="2254769"/>
            <a:ext cx="953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 smtClean="0"/>
              <a:t>M2</a:t>
            </a:r>
            <a:endParaRPr lang="es-MX" dirty="0"/>
          </a:p>
        </p:txBody>
      </p:sp>
      <p:sp>
        <p:nvSpPr>
          <p:cNvPr id="15" name="CuadroTexto 14"/>
          <p:cNvSpPr txBox="1"/>
          <p:nvPr/>
        </p:nvSpPr>
        <p:spPr>
          <a:xfrm>
            <a:off x="8554954" y="2414753"/>
            <a:ext cx="5151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 smtClean="0"/>
              <a:t>M3</a:t>
            </a:r>
            <a:endParaRPr lang="es-MX" dirty="0"/>
          </a:p>
        </p:txBody>
      </p:sp>
      <p:sp>
        <p:nvSpPr>
          <p:cNvPr id="16" name="CuadroTexto 15"/>
          <p:cNvSpPr txBox="1"/>
          <p:nvPr/>
        </p:nvSpPr>
        <p:spPr>
          <a:xfrm>
            <a:off x="7558986" y="2495667"/>
            <a:ext cx="953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 smtClean="0"/>
              <a:t>M4</a:t>
            </a:r>
            <a:endParaRPr lang="es-MX" dirty="0"/>
          </a:p>
        </p:txBody>
      </p:sp>
      <p:sp>
        <p:nvSpPr>
          <p:cNvPr id="17" name="CuadroTexto 16"/>
          <p:cNvSpPr txBox="1"/>
          <p:nvPr/>
        </p:nvSpPr>
        <p:spPr>
          <a:xfrm>
            <a:off x="2757271" y="591446"/>
            <a:ext cx="7152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dirty="0" err="1"/>
              <a:t>p</a:t>
            </a:r>
            <a:r>
              <a:rPr lang="es-MX" dirty="0" err="1" smtClean="0"/>
              <a:t>h</a:t>
            </a:r>
            <a:endParaRPr lang="es-MX" dirty="0"/>
          </a:p>
        </p:txBody>
      </p:sp>
      <p:sp>
        <p:nvSpPr>
          <p:cNvPr id="18" name="CuadroTexto 17"/>
          <p:cNvSpPr txBox="1"/>
          <p:nvPr/>
        </p:nvSpPr>
        <p:spPr>
          <a:xfrm>
            <a:off x="2334457" y="2358481"/>
            <a:ext cx="591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dirty="0" smtClean="0"/>
              <a:t>ci</a:t>
            </a:r>
            <a:endParaRPr lang="es-MX" dirty="0"/>
          </a:p>
        </p:txBody>
      </p:sp>
      <p:cxnSp>
        <p:nvCxnSpPr>
          <p:cNvPr id="20" name="Conector recto de flecha 19"/>
          <p:cNvCxnSpPr/>
          <p:nvPr/>
        </p:nvCxnSpPr>
        <p:spPr>
          <a:xfrm>
            <a:off x="2725119" y="2697915"/>
            <a:ext cx="167425" cy="16708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3" name="Imagen 2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9103" y="2944521"/>
            <a:ext cx="6152009" cy="3184458"/>
          </a:xfrm>
          <a:prstGeom prst="rect">
            <a:avLst/>
          </a:prstGeom>
        </p:spPr>
      </p:pic>
      <p:cxnSp>
        <p:nvCxnSpPr>
          <p:cNvPr id="26" name="Conector recto de flecha 25"/>
          <p:cNvCxnSpPr/>
          <p:nvPr/>
        </p:nvCxnSpPr>
        <p:spPr>
          <a:xfrm flipH="1">
            <a:off x="7569717" y="4336812"/>
            <a:ext cx="487251" cy="2962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CuadroTexto 27"/>
          <p:cNvSpPr txBox="1"/>
          <p:nvPr/>
        </p:nvSpPr>
        <p:spPr>
          <a:xfrm>
            <a:off x="7990450" y="4036476"/>
            <a:ext cx="5215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dirty="0" err="1" smtClean="0"/>
              <a:t>sp</a:t>
            </a:r>
            <a:endParaRPr lang="es-MX" dirty="0" smtClean="0"/>
          </a:p>
        </p:txBody>
      </p:sp>
      <p:sp>
        <p:nvSpPr>
          <p:cNvPr id="29" name="CuadroTexto 28"/>
          <p:cNvSpPr txBox="1"/>
          <p:nvPr/>
        </p:nvSpPr>
        <p:spPr>
          <a:xfrm>
            <a:off x="703025" y="501530"/>
            <a:ext cx="4499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b="1" dirty="0" smtClean="0"/>
              <a:t>A</a:t>
            </a:r>
            <a:endParaRPr lang="es-MX" sz="2400" b="1" dirty="0"/>
          </a:p>
        </p:txBody>
      </p:sp>
      <p:sp>
        <p:nvSpPr>
          <p:cNvPr id="30" name="CuadroTexto 29"/>
          <p:cNvSpPr txBox="1"/>
          <p:nvPr/>
        </p:nvSpPr>
        <p:spPr>
          <a:xfrm>
            <a:off x="4096095" y="450387"/>
            <a:ext cx="5464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b="1" dirty="0"/>
              <a:t>B</a:t>
            </a:r>
          </a:p>
        </p:txBody>
      </p:sp>
      <p:sp>
        <p:nvSpPr>
          <p:cNvPr id="31" name="CuadroTexto 30"/>
          <p:cNvSpPr txBox="1"/>
          <p:nvPr/>
        </p:nvSpPr>
        <p:spPr>
          <a:xfrm>
            <a:off x="4113303" y="2959382"/>
            <a:ext cx="6044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b="1" dirty="0" smtClean="0"/>
              <a:t>C</a:t>
            </a:r>
            <a:endParaRPr lang="es-MX" sz="2400" b="1" dirty="0"/>
          </a:p>
        </p:txBody>
      </p:sp>
      <p:cxnSp>
        <p:nvCxnSpPr>
          <p:cNvPr id="24" name="Conector recto de flecha 23"/>
          <p:cNvCxnSpPr/>
          <p:nvPr/>
        </p:nvCxnSpPr>
        <p:spPr>
          <a:xfrm flipH="1">
            <a:off x="7581440" y="3546677"/>
            <a:ext cx="487251" cy="2962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CuadroTexto 24"/>
          <p:cNvSpPr txBox="1"/>
          <p:nvPr/>
        </p:nvSpPr>
        <p:spPr>
          <a:xfrm>
            <a:off x="7925369" y="3170294"/>
            <a:ext cx="609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dirty="0" smtClean="0"/>
              <a:t>id</a:t>
            </a:r>
            <a:endParaRPr lang="es-MX" dirty="0" smtClean="0"/>
          </a:p>
        </p:txBody>
      </p:sp>
      <p:cxnSp>
        <p:nvCxnSpPr>
          <p:cNvPr id="27" name="Conector recto de flecha 26"/>
          <p:cNvCxnSpPr/>
          <p:nvPr/>
        </p:nvCxnSpPr>
        <p:spPr>
          <a:xfrm flipH="1">
            <a:off x="2757270" y="937111"/>
            <a:ext cx="303131" cy="19069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832659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1152937" y="1343782"/>
            <a:ext cx="988612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MX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es-MX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6. </a:t>
            </a:r>
            <a:r>
              <a:rPr lang="es-MX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male</a:t>
            </a:r>
            <a:r>
              <a:rPr lang="es-MX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MX" sz="2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pygomyia</a:t>
            </a:r>
            <a:r>
              <a:rPr lang="es-MX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2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yennensis</a:t>
            </a:r>
            <a:r>
              <a:rPr lang="es-MX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20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ciasi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nt view of the head</a:t>
            </a:r>
            <a:r>
              <a:rPr lang="es-MX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s-MX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ng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C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vidual </a:t>
            </a:r>
            <a:r>
              <a:rPr lang="es-MX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ct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id) and </a:t>
            </a:r>
            <a:r>
              <a:rPr lang="es-MX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s-MX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matheca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MX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s-MX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age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arification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dium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droxide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MX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s-MX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s-MX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rinx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ci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s-MX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ibarium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R1-5: 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dial </a:t>
            </a:r>
            <a:r>
              <a:rPr lang="es-MX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ins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M1- M4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s-MX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ddle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ins</a:t>
            </a:r>
            <a:r>
              <a:rPr lang="es-MX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s-MX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s-MX" sz="2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53034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30</Words>
  <Application>Microsoft Office PowerPoint</Application>
  <PresentationFormat>Panorámica</PresentationFormat>
  <Paragraphs>19</Paragraphs>
  <Slides>2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José Ríos Tostado</dc:creator>
  <cp:lastModifiedBy>Juan José Ríos Tostado</cp:lastModifiedBy>
  <cp:revision>2</cp:revision>
  <dcterms:created xsi:type="dcterms:W3CDTF">2026-06-03T03:59:34Z</dcterms:created>
  <dcterms:modified xsi:type="dcterms:W3CDTF">2026-06-03T04:04:40Z</dcterms:modified>
</cp:coreProperties>
</file>